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2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87365F-FAAF-4FF5-B722-37AB286D01B6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E59876-BCBA-46FE-B12B-E0FDC725C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72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47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515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830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618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650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354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222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256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904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150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012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30E7E-FA2A-48D3-85F0-4F79A6513D0F}" type="datetimeFigureOut">
              <a:rPr lang="en-US" smtClean="0"/>
              <a:t>9/16/2021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498EA-5EF6-4D72-8756-8111AE44EF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04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0970" y="1380566"/>
            <a:ext cx="9730059" cy="4096867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96E76497-9FFA-4E72-B40E-B8D83193454C}"/>
              </a:ext>
            </a:extLst>
          </p:cNvPr>
          <p:cNvSpPr txBox="1"/>
          <p:nvPr/>
        </p:nvSpPr>
        <p:spPr>
          <a:xfrm>
            <a:off x="3196228" y="950710"/>
            <a:ext cx="2899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a: </a:t>
            </a:r>
            <a:r>
              <a:rPr lang="en-US" altLang="zh-CN" sz="1200" dirty="0" err="1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r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osmarinic</a:t>
            </a:r>
            <a:r>
              <a:rPr lang="en-US" altLang="zh-CN" sz="1200" dirty="0" smtClean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acid       b: </a:t>
            </a:r>
            <a:r>
              <a:rPr lang="en-US" altLang="zh-CN" sz="1200" dirty="0" err="1" smtClean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salvianolic</a:t>
            </a:r>
            <a:r>
              <a:rPr lang="en-US" altLang="zh-CN" sz="1200" dirty="0" smtClean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acid </a:t>
            </a:r>
            <a:r>
              <a:rPr lang="en-US" altLang="zh-CN" sz="1200" dirty="0" smtClean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  <a:sym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  <a:sym typeface="Times New Roman" panose="02020603050405020304" pitchFamily="18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048103" y="5477433"/>
            <a:ext cx="1009579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Total ion chromatograms of roots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via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iorrhiz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btained by high performance liquid chromatography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L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alysis used for quantificat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vianol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B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marin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id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36095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00000000-0008-0000-0100-00000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0694" y="798746"/>
            <a:ext cx="9920168" cy="22334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1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6746" y="3292720"/>
            <a:ext cx="10028064" cy="22334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文本框 3"/>
          <p:cNvSpPr txBox="1"/>
          <p:nvPr/>
        </p:nvSpPr>
        <p:spPr>
          <a:xfrm>
            <a:off x="1297858" y="429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297858" y="298101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031C04D0-B40E-462D-8A67-695A0AA751F1}"/>
              </a:ext>
            </a:extLst>
          </p:cNvPr>
          <p:cNvSpPr/>
          <p:nvPr/>
        </p:nvSpPr>
        <p:spPr>
          <a:xfrm>
            <a:off x="349045" y="5639208"/>
            <a:ext cx="1184295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Total ion chromatogram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via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iorrhiz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(A) and with (B) copper treatmen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wo-month-ol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iorrhiz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treated without or with low copper ion 5 days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etabolites were extracted using 70% methanol diluted in deionized water. Metabolites were determin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ultr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ance liquid chromatography-quadrupole-time of flight mas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ometry (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L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Q/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F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MS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otal ions were counted within 90 min.</a:t>
            </a:r>
          </a:p>
        </p:txBody>
      </p:sp>
    </p:spTree>
    <p:extLst>
      <p:ext uri="{BB962C8B-B14F-4D97-AF65-F5344CB8AC3E}">
        <p14:creationId xmlns:p14="http://schemas.microsoft.com/office/powerpoint/2010/main" val="318921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/>
          <p:cNvGrpSpPr/>
          <p:nvPr/>
        </p:nvGrpSpPr>
        <p:grpSpPr>
          <a:xfrm>
            <a:off x="1134077" y="831855"/>
            <a:ext cx="9478484" cy="4086731"/>
            <a:chOff x="1104581" y="1171068"/>
            <a:chExt cx="9478484" cy="408673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9" t="47436" r="17272" b="4030"/>
            <a:stretch/>
          </p:blipFill>
          <p:spPr>
            <a:xfrm>
              <a:off x="1106129" y="3303639"/>
              <a:ext cx="7757652" cy="1954160"/>
            </a:xfrm>
            <a:prstGeom prst="rect">
              <a:avLst/>
            </a:prstGeom>
          </p:spPr>
        </p:pic>
        <p:grpSp>
          <p:nvGrpSpPr>
            <p:cNvPr id="16" name="组合 15"/>
            <p:cNvGrpSpPr/>
            <p:nvPr/>
          </p:nvGrpSpPr>
          <p:grpSpPr>
            <a:xfrm>
              <a:off x="2218767" y="1171068"/>
              <a:ext cx="4242117" cy="1384444"/>
              <a:chOff x="5891115" y="175914"/>
              <a:chExt cx="4242117" cy="1384444"/>
            </a:xfrm>
          </p:grpSpPr>
          <p:sp>
            <p:nvSpPr>
              <p:cNvPr id="6" name="文本框 5"/>
              <p:cNvSpPr txBox="1"/>
              <p:nvPr/>
            </p:nvSpPr>
            <p:spPr>
              <a:xfrm>
                <a:off x="6425023" y="526385"/>
                <a:ext cx="23871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E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Metal response-element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6425023" y="175914"/>
                <a:ext cx="25458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uRE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Copper response-element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6415548" y="1237900"/>
                <a:ext cx="371768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B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B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ranscription factor binding element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/>
            </p:nvSpPr>
            <p:spPr>
              <a:xfrm>
                <a:off x="6408428" y="878509"/>
                <a:ext cx="34628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E</a:t>
                </a:r>
                <a:r>
                  <a:rPr lang="en-US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like, Metal response-element like motif</a:t>
                </a:r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2" name="图片 1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025" t="5008" r="9410" b="86928"/>
              <a:stretch/>
            </p:blipFill>
            <p:spPr>
              <a:xfrm>
                <a:off x="5902066" y="547356"/>
                <a:ext cx="535858" cy="324658"/>
              </a:xfrm>
              <a:prstGeom prst="rect">
                <a:avLst/>
              </a:prstGeom>
            </p:spPr>
          </p:pic>
          <p:pic>
            <p:nvPicPr>
              <p:cNvPr id="13" name="图片 1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025" t="13956" r="9202" b="79451"/>
              <a:stretch/>
            </p:blipFill>
            <p:spPr>
              <a:xfrm>
                <a:off x="5903941" y="223902"/>
                <a:ext cx="555851" cy="265471"/>
              </a:xfrm>
              <a:prstGeom prst="rect">
                <a:avLst/>
              </a:prstGeom>
            </p:spPr>
          </p:pic>
          <p:pic>
            <p:nvPicPr>
              <p:cNvPr id="14" name="图片 1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025" t="23506" r="9924" b="70267"/>
              <a:stretch/>
            </p:blipFill>
            <p:spPr>
              <a:xfrm>
                <a:off x="5914358" y="1309635"/>
                <a:ext cx="486442" cy="250723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5025" t="31381" r="9449" b="60195"/>
              <a:stretch/>
            </p:blipFill>
            <p:spPr>
              <a:xfrm>
                <a:off x="5891115" y="914364"/>
                <a:ext cx="532061" cy="339213"/>
              </a:xfrm>
              <a:prstGeom prst="rect">
                <a:avLst/>
              </a:prstGeom>
            </p:spPr>
          </p:pic>
        </p:grpSp>
        <p:sp>
          <p:nvSpPr>
            <p:cNvPr id="2" name="矩形 1"/>
            <p:cNvSpPr/>
            <p:nvPr/>
          </p:nvSpPr>
          <p:spPr>
            <a:xfrm>
              <a:off x="8585306" y="4055494"/>
              <a:ext cx="9140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accase 20 </a:t>
              </a:r>
              <a:endParaRPr lang="en-US" sz="1200" dirty="0"/>
            </a:p>
          </p:txBody>
        </p:sp>
        <p:sp>
          <p:nvSpPr>
            <p:cNvPr id="3" name="矩形 2"/>
            <p:cNvSpPr/>
            <p:nvPr/>
          </p:nvSpPr>
          <p:spPr>
            <a:xfrm>
              <a:off x="8582196" y="4389208"/>
              <a:ext cx="9140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accase 13 </a:t>
              </a:r>
              <a:endParaRPr lang="en-US" sz="1200" dirty="0"/>
            </a:p>
          </p:txBody>
        </p:sp>
        <p:sp>
          <p:nvSpPr>
            <p:cNvPr id="5" name="矩形 4"/>
            <p:cNvSpPr/>
            <p:nvPr/>
          </p:nvSpPr>
          <p:spPr>
            <a:xfrm>
              <a:off x="8555810" y="3696568"/>
              <a:ext cx="199067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cription factor </a:t>
              </a:r>
              <a:r>
                <a:rPr lang="en-US" sz="12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YB33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  <p:sp>
          <p:nvSpPr>
            <p:cNvPr id="10" name="矩形 9"/>
            <p:cNvSpPr/>
            <p:nvPr/>
          </p:nvSpPr>
          <p:spPr>
            <a:xfrm>
              <a:off x="8555810" y="3341984"/>
              <a:ext cx="199067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cription factor </a:t>
              </a:r>
              <a:r>
                <a:rPr lang="en-US" sz="12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YB73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  <p:pic>
          <p:nvPicPr>
            <p:cNvPr id="17" name="图片 1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9" t="20147" r="17272" b="60981"/>
            <a:stretch/>
          </p:blipFill>
          <p:spPr>
            <a:xfrm>
              <a:off x="1104581" y="2574816"/>
              <a:ext cx="7757652" cy="759854"/>
            </a:xfrm>
            <a:prstGeom prst="rect">
              <a:avLst/>
            </a:prstGeom>
          </p:spPr>
        </p:pic>
        <p:sp>
          <p:nvSpPr>
            <p:cNvPr id="11" name="矩形 10"/>
            <p:cNvSpPr/>
            <p:nvPr/>
          </p:nvSpPr>
          <p:spPr>
            <a:xfrm>
              <a:off x="8582196" y="3017248"/>
              <a:ext cx="20008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inc finger </a:t>
              </a:r>
              <a:r>
                <a:rPr lang="en-US" sz="12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CCH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otein 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3</a:t>
              </a:r>
              <a:endParaRPr lang="en-US" sz="1200" dirty="0"/>
            </a:p>
          </p:txBody>
        </p:sp>
        <p:sp>
          <p:nvSpPr>
            <p:cNvPr id="18" name="矩形 17"/>
            <p:cNvSpPr/>
            <p:nvPr/>
          </p:nvSpPr>
          <p:spPr>
            <a:xfrm>
              <a:off x="8586398" y="2683402"/>
              <a:ext cx="18651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inc finger protein </a:t>
              </a:r>
              <a:r>
                <a:rPr lang="en-US" sz="1200" dirty="0" err="1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AT10</a:t>
              </a:r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</p:grpSp>
      <p:sp>
        <p:nvSpPr>
          <p:cNvPr id="20" name="矩形 19"/>
          <p:cNvSpPr/>
          <p:nvPr/>
        </p:nvSpPr>
        <p:spPr>
          <a:xfrm>
            <a:off x="776748" y="5155860"/>
            <a:ext cx="1088922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Copper-response element predication in laccases and transcription factors. The promoter sequences of analyzed genes (from 20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lative to translation start site) were extract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ff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via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iorrhiza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. Core motif of copper-response elemen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TA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l response-elemen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CxCx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in extracted 20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sequences of laccases and transcription factors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ca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ualized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Btoo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addition, transcription factors binding motifs were also predicated in extracted 20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sequences of laccases. </a:t>
            </a:r>
          </a:p>
        </p:txBody>
      </p:sp>
    </p:spTree>
    <p:extLst>
      <p:ext uri="{BB962C8B-B14F-4D97-AF65-F5344CB8AC3E}">
        <p14:creationId xmlns:p14="http://schemas.microsoft.com/office/powerpoint/2010/main" val="4213110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5</TotalTime>
  <Words>252</Words>
  <Application>Microsoft Office PowerPoint</Application>
  <PresentationFormat>宽屏</PresentationFormat>
  <Paragraphs>1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等线</vt:lpstr>
      <vt:lpstr>等线 Light</vt:lpstr>
      <vt:lpstr>微软雅黑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·çÇáÎÞºÛ</dc:creator>
  <cp:lastModifiedBy>·çÇáÎÞºÛ</cp:lastModifiedBy>
  <cp:revision>33</cp:revision>
  <dcterms:created xsi:type="dcterms:W3CDTF">2021-06-19T01:36:03Z</dcterms:created>
  <dcterms:modified xsi:type="dcterms:W3CDTF">2021-09-16T03:00:14Z</dcterms:modified>
</cp:coreProperties>
</file>